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B0F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5574"/>
    <p:restoredTop sz="96132"/>
  </p:normalViewPr>
  <p:slideViewPr>
    <p:cSldViewPr snapToGrid="0">
      <p:cViewPr varScale="1">
        <p:scale>
          <a:sx n="121" d="100"/>
          <a:sy n="121" d="100"/>
        </p:scale>
        <p:origin x="104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839327-D519-0BB6-0F76-8C625C36AF2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7D5FB79-4459-386F-2887-C5A57C694F1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5549B1-33DA-3C62-B74C-28F798C88E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BF68F-2932-994A-84C2-67AADD608ACA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94C210-1964-D357-8715-79D580280D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B9909D-896B-E312-FD32-F46A3EEFE1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419A-A2CD-AF4A-99AD-BD9C772E043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37275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2E1A1C-422B-8956-6C48-2D6D4E2581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A572C63-3A59-9A79-DEE6-FC1929D68E8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D8BE543-17AC-3295-7ADD-B410DF2A70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BF68F-2932-994A-84C2-67AADD608ACA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2E5468-A8F2-BA3A-1BA5-6AD55792E5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F1F668-2476-F941-6D41-FB5AA2EED9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419A-A2CD-AF4A-99AD-BD9C772E043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24741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B5CF20A-696F-327F-CD8E-5AB080C5AA1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CF6D175-BF25-E805-2A9D-3C6DF26690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327E06-C2C1-7052-2165-AEFE16E22B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BF68F-2932-994A-84C2-67AADD608ACA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764B15-8BAE-7466-89A0-FDF6F2BDAB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0990C9-EE39-D28A-0AEB-F42B9B1B29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419A-A2CD-AF4A-99AD-BD9C772E043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62135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044C07-4F99-F3F9-16DD-8B4F724342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66B16A6-F298-B86C-C2C4-976CC6A1BF0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F71BA6-A0B6-074C-D932-CCDD3857FC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BF68F-2932-994A-84C2-67AADD608ACA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7A245E-D8B5-DB33-9C41-7B05DE90AE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D46E09-3CCA-3659-4155-0DB2374899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419A-A2CD-AF4A-99AD-BD9C772E043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00714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412950-520B-1A05-071E-082FDD87DD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8B117DF-B750-ECA2-640D-877E48F898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CB1742-B1D0-41C3-A9D7-5F993C8C23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BF68F-2932-994A-84C2-67AADD608ACA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8A1B38-6C25-8438-C7FD-9467F96C4B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E980A6-F742-1A32-3199-71AB8146A4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419A-A2CD-AF4A-99AD-BD9C772E043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88216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0ADC17-316D-A905-4D83-5B7A31E08A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DB0FCE-F49A-C52D-DC33-8A316F5393A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EAB1EEE-79AC-13B5-D19F-88480FD816B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CC72213-F1DF-EC18-5ACA-A3ACB93E5D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BF68F-2932-994A-84C2-67AADD608ACA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5E275CD-E1DC-5F9F-D6F0-953F97BC8A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5256F87-83D9-A375-2739-B91D393AC3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419A-A2CD-AF4A-99AD-BD9C772E043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41031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3A6F5F-60AF-AB9D-E69C-D47FF989FF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7F5F32-F4C7-A98D-08A3-D20F6A464C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D8B38EA-428D-EEB0-0879-01C2F787629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4345E29-9018-6A3D-0DB6-F12F0B76F11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063DC91-7AC4-7B4B-02CD-4BE3D419961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D35337F-9823-F51A-C6E8-88BFD1D58A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BF68F-2932-994A-84C2-67AADD608ACA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87A8E09-9C35-27E0-CDDB-CF6D62C81B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B05A79D-BA4D-5002-4512-05F39D7982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419A-A2CD-AF4A-99AD-BD9C772E043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40881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7B6C22-3DEB-AF2A-8DE8-9FF887DDF00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EB910D3-B744-F220-6E1C-F5B8CFE0AA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BF68F-2932-994A-84C2-67AADD608ACA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E9BAEBB-6114-E3DB-49DF-D9FBD93E91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C522AE7-C6A5-2391-AF46-A77B1BDFD5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419A-A2CD-AF4A-99AD-BD9C772E043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34446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862CB14-F7BC-C9EA-FF6A-5FE7843CB1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BF68F-2932-994A-84C2-67AADD608ACA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0D23C25-3853-02EA-47F2-CB45313C0D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7B9483E-E719-183D-2E00-5D22C79959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419A-A2CD-AF4A-99AD-BD9C772E043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68764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8253A8-B333-7E49-17E5-E589DC28DA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CE57140-943B-73E8-39B9-FBF059A8FAF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9126167-F51E-E6BC-214F-3234DFF99E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7119FBE-A791-91AC-9132-1BCD543BFD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BF68F-2932-994A-84C2-67AADD608ACA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29BD79A-CACA-36F7-AAE7-EF61E29BE4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0B8F943-0E35-3AA1-4D59-88604E114A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419A-A2CD-AF4A-99AD-BD9C772E043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9532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7FA371-270F-0717-CB15-38042E3471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872BEFE-DDEC-E8FB-58AA-D2A1614D82D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C40C368-9557-E9B4-B50A-7C4E3577E6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4250C79-DFAD-405A-B9DF-A9012EB4B4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2BF68F-2932-994A-84C2-67AADD608ACA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A65832-4BFE-E7E9-423B-EE53BC432A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CFB7263-EB66-DE0E-42D8-2177E4DA7B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D5419A-A2CD-AF4A-99AD-BD9C772E043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73030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B86CA10-4CE6-F7E8-0572-398ABC3894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EE4E648-3FA7-E7B2-E436-CF7A963452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24B70B-22A9-99D6-4D64-8A3F46A35E4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2BF68F-2932-994A-84C2-67AADD608ACA}" type="datetimeFigureOut">
              <a:rPr lang="en-GB" smtClean="0"/>
              <a:t>27/09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C83438-FAA2-60D5-9AE3-E0A4AF6A69E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D114F6-BC88-EB4C-2993-5BE089CE4CB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D5419A-A2CD-AF4A-99AD-BD9C772E043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03315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83E2241-0274-9F1C-BE9A-5E3FE46365C8}"/>
              </a:ext>
            </a:extLst>
          </p:cNvPr>
          <p:cNvSpPr txBox="1"/>
          <p:nvPr/>
        </p:nvSpPr>
        <p:spPr>
          <a:xfrm>
            <a:off x="6216497" y="658846"/>
            <a:ext cx="5868970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Figure S5: </a:t>
            </a:r>
            <a:r>
              <a:rPr lang="da-DK" sz="1200" b="1" dirty="0"/>
              <a:t>The </a:t>
            </a:r>
            <a:r>
              <a:rPr lang="en-GB" sz="1200" b="1" dirty="0"/>
              <a:t>conservation</a:t>
            </a:r>
            <a:r>
              <a:rPr lang="en-US" sz="1200" b="1" dirty="0"/>
              <a:t> of the Sclerotiniaceae and Rutstroemiaceae </a:t>
            </a:r>
            <a:r>
              <a:rPr lang="da-DK" sz="1200" b="1" dirty="0"/>
              <a:t>a</a:t>
            </a:r>
            <a:r>
              <a:rPr lang="en-US" sz="1200" b="1" dirty="0"/>
              <a:t>-factor pheromones. </a:t>
            </a:r>
            <a:r>
              <a:rPr lang="en-US" sz="1200" dirty="0"/>
              <a:t>The a-factor pheromone in these two families was highly conserved and, in many cases, identical within the two families. 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68F68D68-2F26-396D-A9AF-37713D1242B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6906"/>
          <a:stretch/>
        </p:blipFill>
        <p:spPr>
          <a:xfrm>
            <a:off x="347526" y="392589"/>
            <a:ext cx="5627974" cy="424057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275D7920-90AA-DD7B-D545-4CDF6CA04A6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63380"/>
          <a:stretch/>
        </p:blipFill>
        <p:spPr>
          <a:xfrm>
            <a:off x="347526" y="4892173"/>
            <a:ext cx="5627974" cy="1668101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4940E6EF-BC86-E578-8DB7-7F485A17B9E6}"/>
              </a:ext>
            </a:extLst>
          </p:cNvPr>
          <p:cNvSpPr/>
          <p:nvPr/>
        </p:nvSpPr>
        <p:spPr>
          <a:xfrm>
            <a:off x="227028" y="128955"/>
            <a:ext cx="5868971" cy="450421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54EEF41F-355C-69B0-90D6-66D81CFD42E9}"/>
              </a:ext>
            </a:extLst>
          </p:cNvPr>
          <p:cNvSpPr/>
          <p:nvPr/>
        </p:nvSpPr>
        <p:spPr>
          <a:xfrm flipV="1">
            <a:off x="227028" y="4629299"/>
            <a:ext cx="5868971" cy="205285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DBB9BDB-5377-CE36-6A1D-6F8F71711248}"/>
              </a:ext>
            </a:extLst>
          </p:cNvPr>
          <p:cNvSpPr txBox="1"/>
          <p:nvPr/>
        </p:nvSpPr>
        <p:spPr>
          <a:xfrm>
            <a:off x="2024375" y="148909"/>
            <a:ext cx="22742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Sclerotiniaceae</a:t>
            </a:r>
            <a:endParaRPr lang="en-US" sz="16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76D68E3-4E91-A980-C917-2A7E5AB63D54}"/>
              </a:ext>
            </a:extLst>
          </p:cNvPr>
          <p:cNvSpPr txBox="1"/>
          <p:nvPr/>
        </p:nvSpPr>
        <p:spPr>
          <a:xfrm>
            <a:off x="2024375" y="4629300"/>
            <a:ext cx="22742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/>
              <a:t>Rutstroemiaceae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12557265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53</TotalTime>
  <Words>38</Words>
  <Application>Microsoft Macintosh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i Wilson</dc:creator>
  <cp:lastModifiedBy>Andi Wilson</cp:lastModifiedBy>
  <cp:revision>43</cp:revision>
  <dcterms:created xsi:type="dcterms:W3CDTF">2023-01-19T13:08:01Z</dcterms:created>
  <dcterms:modified xsi:type="dcterms:W3CDTF">2023-09-27T09:23:20Z</dcterms:modified>
</cp:coreProperties>
</file>